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9" r:id="rId2"/>
    <p:sldId id="258" r:id="rId3"/>
  </p:sldIdLst>
  <p:sldSz cx="953928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267">
          <p15:clr>
            <a:srgbClr val="A4A3A4"/>
          </p15:clr>
        </p15:guide>
        <p15:guide id="2" pos="30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264" autoAdjust="0"/>
  </p:normalViewPr>
  <p:slideViewPr>
    <p:cSldViewPr snapToGrid="0">
      <p:cViewPr>
        <p:scale>
          <a:sx n="80" d="100"/>
          <a:sy n="80" d="100"/>
        </p:scale>
        <p:origin x="-792" y="-480"/>
      </p:cViewPr>
      <p:guideLst>
        <p:guide orient="horz" pos="2267"/>
        <p:guide pos="30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7DB989-BACE-4011-B2EF-23261DA47CF2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84300" y="1143000"/>
            <a:ext cx="4089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51B2F3-2E7F-4813-B8B3-EC527C16332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5623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1pPr>
    <a:lvl2pPr marL="433791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2pPr>
    <a:lvl3pPr marL="867583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3pPr>
    <a:lvl4pPr marL="1301374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4pPr>
    <a:lvl5pPr marL="1735165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5pPr>
    <a:lvl6pPr marL="2168957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6pPr>
    <a:lvl7pPr marL="2602748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7pPr>
    <a:lvl8pPr marL="3036540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8pPr>
    <a:lvl9pPr marL="3470331" algn="l" defTabSz="867583" rtl="0" eaLnBrk="1" latinLnBrk="0" hangingPunct="1">
      <a:defRPr sz="113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5447" y="1178222"/>
            <a:ext cx="8108395" cy="2506427"/>
          </a:xfrm>
        </p:spPr>
        <p:txBody>
          <a:bodyPr anchor="b"/>
          <a:lstStyle>
            <a:lvl1pPr algn="ctr">
              <a:defRPr sz="6259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92411" y="3781306"/>
            <a:ext cx="7154466" cy="1738167"/>
          </a:xfrm>
        </p:spPr>
        <p:txBody>
          <a:bodyPr/>
          <a:lstStyle>
            <a:lvl1pPr marL="0" indent="0" algn="ctr">
              <a:buNone/>
              <a:defRPr sz="2504"/>
            </a:lvl1pPr>
            <a:lvl2pPr marL="476951" indent="0" algn="ctr">
              <a:buNone/>
              <a:defRPr sz="2086"/>
            </a:lvl2pPr>
            <a:lvl3pPr marL="953902" indent="0" algn="ctr">
              <a:buNone/>
              <a:defRPr sz="1878"/>
            </a:lvl3pPr>
            <a:lvl4pPr marL="1430853" indent="0" algn="ctr">
              <a:buNone/>
              <a:defRPr sz="1669"/>
            </a:lvl4pPr>
            <a:lvl5pPr marL="1907804" indent="0" algn="ctr">
              <a:buNone/>
              <a:defRPr sz="1669"/>
            </a:lvl5pPr>
            <a:lvl6pPr marL="2384755" indent="0" algn="ctr">
              <a:buNone/>
              <a:defRPr sz="1669"/>
            </a:lvl6pPr>
            <a:lvl7pPr marL="2861706" indent="0" algn="ctr">
              <a:buNone/>
              <a:defRPr sz="1669"/>
            </a:lvl7pPr>
            <a:lvl8pPr marL="3338657" indent="0" algn="ctr">
              <a:buNone/>
              <a:defRPr sz="1669"/>
            </a:lvl8pPr>
            <a:lvl9pPr marL="3815608" indent="0" algn="ctr">
              <a:buNone/>
              <a:defRPr sz="1669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10799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348361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26553" y="383297"/>
            <a:ext cx="2056909" cy="610108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5826" y="383297"/>
            <a:ext cx="6051486" cy="6101085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310905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75849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0858" y="1794831"/>
            <a:ext cx="8227636" cy="2994714"/>
          </a:xfrm>
        </p:spPr>
        <p:txBody>
          <a:bodyPr anchor="b"/>
          <a:lstStyle>
            <a:lvl1pPr>
              <a:defRPr sz="6259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0858" y="4817876"/>
            <a:ext cx="8227636" cy="1574849"/>
          </a:xfrm>
        </p:spPr>
        <p:txBody>
          <a:bodyPr/>
          <a:lstStyle>
            <a:lvl1pPr marL="0" indent="0">
              <a:buNone/>
              <a:defRPr sz="2504">
                <a:solidFill>
                  <a:schemeClr val="tx1"/>
                </a:solidFill>
              </a:defRPr>
            </a:lvl1pPr>
            <a:lvl2pPr marL="476951" indent="0">
              <a:buNone/>
              <a:defRPr sz="2086">
                <a:solidFill>
                  <a:schemeClr val="tx1">
                    <a:tint val="75000"/>
                  </a:schemeClr>
                </a:solidFill>
              </a:defRPr>
            </a:lvl2pPr>
            <a:lvl3pPr marL="953902" indent="0">
              <a:buNone/>
              <a:defRPr sz="1878">
                <a:solidFill>
                  <a:schemeClr val="tx1">
                    <a:tint val="75000"/>
                  </a:schemeClr>
                </a:solidFill>
              </a:defRPr>
            </a:lvl3pPr>
            <a:lvl4pPr marL="1430853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4pPr>
            <a:lvl5pPr marL="1907804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5pPr>
            <a:lvl6pPr marL="2384755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6pPr>
            <a:lvl7pPr marL="2861706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7pPr>
            <a:lvl8pPr marL="3338657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8pPr>
            <a:lvl9pPr marL="3815608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610273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55826" y="1916484"/>
            <a:ext cx="4054197" cy="456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29265" y="1916484"/>
            <a:ext cx="4054197" cy="456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80765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383299"/>
            <a:ext cx="8227636" cy="1391534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7070" y="1764832"/>
            <a:ext cx="4035565" cy="864917"/>
          </a:xfrm>
        </p:spPr>
        <p:txBody>
          <a:bodyPr anchor="b"/>
          <a:lstStyle>
            <a:lvl1pPr marL="0" indent="0">
              <a:buNone/>
              <a:defRPr sz="2504" b="1"/>
            </a:lvl1pPr>
            <a:lvl2pPr marL="476951" indent="0">
              <a:buNone/>
              <a:defRPr sz="2086" b="1"/>
            </a:lvl2pPr>
            <a:lvl3pPr marL="953902" indent="0">
              <a:buNone/>
              <a:defRPr sz="1878" b="1"/>
            </a:lvl3pPr>
            <a:lvl4pPr marL="1430853" indent="0">
              <a:buNone/>
              <a:defRPr sz="1669" b="1"/>
            </a:lvl4pPr>
            <a:lvl5pPr marL="1907804" indent="0">
              <a:buNone/>
              <a:defRPr sz="1669" b="1"/>
            </a:lvl5pPr>
            <a:lvl6pPr marL="2384755" indent="0">
              <a:buNone/>
              <a:defRPr sz="1669" b="1"/>
            </a:lvl6pPr>
            <a:lvl7pPr marL="2861706" indent="0">
              <a:buNone/>
              <a:defRPr sz="1669" b="1"/>
            </a:lvl7pPr>
            <a:lvl8pPr marL="3338657" indent="0">
              <a:buNone/>
              <a:defRPr sz="1669" b="1"/>
            </a:lvl8pPr>
            <a:lvl9pPr marL="3815608" indent="0">
              <a:buNone/>
              <a:defRPr sz="1669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7070" y="2629749"/>
            <a:ext cx="4035565" cy="3867965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29265" y="1764832"/>
            <a:ext cx="4055440" cy="864917"/>
          </a:xfrm>
        </p:spPr>
        <p:txBody>
          <a:bodyPr anchor="b"/>
          <a:lstStyle>
            <a:lvl1pPr marL="0" indent="0">
              <a:buNone/>
              <a:defRPr sz="2504" b="1"/>
            </a:lvl1pPr>
            <a:lvl2pPr marL="476951" indent="0">
              <a:buNone/>
              <a:defRPr sz="2086" b="1"/>
            </a:lvl2pPr>
            <a:lvl3pPr marL="953902" indent="0">
              <a:buNone/>
              <a:defRPr sz="1878" b="1"/>
            </a:lvl3pPr>
            <a:lvl4pPr marL="1430853" indent="0">
              <a:buNone/>
              <a:defRPr sz="1669" b="1"/>
            </a:lvl4pPr>
            <a:lvl5pPr marL="1907804" indent="0">
              <a:buNone/>
              <a:defRPr sz="1669" b="1"/>
            </a:lvl5pPr>
            <a:lvl6pPr marL="2384755" indent="0">
              <a:buNone/>
              <a:defRPr sz="1669" b="1"/>
            </a:lvl6pPr>
            <a:lvl7pPr marL="2861706" indent="0">
              <a:buNone/>
              <a:defRPr sz="1669" b="1"/>
            </a:lvl7pPr>
            <a:lvl8pPr marL="3338657" indent="0">
              <a:buNone/>
              <a:defRPr sz="1669" b="1"/>
            </a:lvl8pPr>
            <a:lvl9pPr marL="3815608" indent="0">
              <a:buNone/>
              <a:defRPr sz="1669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29265" y="2629749"/>
            <a:ext cx="4055440" cy="3867965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54707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320787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417791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479954"/>
            <a:ext cx="3076669" cy="1679840"/>
          </a:xfrm>
        </p:spPr>
        <p:txBody>
          <a:bodyPr anchor="b"/>
          <a:lstStyle>
            <a:lvl1pPr>
              <a:defRPr sz="333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55440" y="1036570"/>
            <a:ext cx="4829265" cy="5116178"/>
          </a:xfrm>
        </p:spPr>
        <p:txBody>
          <a:bodyPr/>
          <a:lstStyle>
            <a:lvl1pPr>
              <a:defRPr sz="3338"/>
            </a:lvl1pPr>
            <a:lvl2pPr>
              <a:defRPr sz="2921"/>
            </a:lvl2pPr>
            <a:lvl3pPr>
              <a:defRPr sz="2504"/>
            </a:lvl3pPr>
            <a:lvl4pPr>
              <a:defRPr sz="2086"/>
            </a:lvl4pPr>
            <a:lvl5pPr>
              <a:defRPr sz="2086"/>
            </a:lvl5pPr>
            <a:lvl6pPr>
              <a:defRPr sz="2086"/>
            </a:lvl6pPr>
            <a:lvl7pPr>
              <a:defRPr sz="2086"/>
            </a:lvl7pPr>
            <a:lvl8pPr>
              <a:defRPr sz="2086"/>
            </a:lvl8pPr>
            <a:lvl9pPr>
              <a:defRPr sz="2086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57068" y="2159794"/>
            <a:ext cx="3076669" cy="4001285"/>
          </a:xfrm>
        </p:spPr>
        <p:txBody>
          <a:bodyPr/>
          <a:lstStyle>
            <a:lvl1pPr marL="0" indent="0">
              <a:buNone/>
              <a:defRPr sz="1669"/>
            </a:lvl1pPr>
            <a:lvl2pPr marL="476951" indent="0">
              <a:buNone/>
              <a:defRPr sz="1460"/>
            </a:lvl2pPr>
            <a:lvl3pPr marL="953902" indent="0">
              <a:buNone/>
              <a:defRPr sz="1252"/>
            </a:lvl3pPr>
            <a:lvl4pPr marL="1430853" indent="0">
              <a:buNone/>
              <a:defRPr sz="1043"/>
            </a:lvl4pPr>
            <a:lvl5pPr marL="1907804" indent="0">
              <a:buNone/>
              <a:defRPr sz="1043"/>
            </a:lvl5pPr>
            <a:lvl6pPr marL="2384755" indent="0">
              <a:buNone/>
              <a:defRPr sz="1043"/>
            </a:lvl6pPr>
            <a:lvl7pPr marL="2861706" indent="0">
              <a:buNone/>
              <a:defRPr sz="1043"/>
            </a:lvl7pPr>
            <a:lvl8pPr marL="3338657" indent="0">
              <a:buNone/>
              <a:defRPr sz="1043"/>
            </a:lvl8pPr>
            <a:lvl9pPr marL="3815608" indent="0">
              <a:buNone/>
              <a:defRPr sz="1043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117409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479954"/>
            <a:ext cx="3076669" cy="1679840"/>
          </a:xfrm>
        </p:spPr>
        <p:txBody>
          <a:bodyPr anchor="b"/>
          <a:lstStyle>
            <a:lvl1pPr>
              <a:defRPr sz="333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55440" y="1036570"/>
            <a:ext cx="4829265" cy="5116178"/>
          </a:xfrm>
        </p:spPr>
        <p:txBody>
          <a:bodyPr anchor="t"/>
          <a:lstStyle>
            <a:lvl1pPr marL="0" indent="0">
              <a:buNone/>
              <a:defRPr sz="3338"/>
            </a:lvl1pPr>
            <a:lvl2pPr marL="476951" indent="0">
              <a:buNone/>
              <a:defRPr sz="2921"/>
            </a:lvl2pPr>
            <a:lvl3pPr marL="953902" indent="0">
              <a:buNone/>
              <a:defRPr sz="2504"/>
            </a:lvl3pPr>
            <a:lvl4pPr marL="1430853" indent="0">
              <a:buNone/>
              <a:defRPr sz="2086"/>
            </a:lvl4pPr>
            <a:lvl5pPr marL="1907804" indent="0">
              <a:buNone/>
              <a:defRPr sz="2086"/>
            </a:lvl5pPr>
            <a:lvl6pPr marL="2384755" indent="0">
              <a:buNone/>
              <a:defRPr sz="2086"/>
            </a:lvl6pPr>
            <a:lvl7pPr marL="2861706" indent="0">
              <a:buNone/>
              <a:defRPr sz="2086"/>
            </a:lvl7pPr>
            <a:lvl8pPr marL="3338657" indent="0">
              <a:buNone/>
              <a:defRPr sz="2086"/>
            </a:lvl8pPr>
            <a:lvl9pPr marL="3815608" indent="0">
              <a:buNone/>
              <a:defRPr sz="2086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57068" y="2159794"/>
            <a:ext cx="3076669" cy="4001285"/>
          </a:xfrm>
        </p:spPr>
        <p:txBody>
          <a:bodyPr/>
          <a:lstStyle>
            <a:lvl1pPr marL="0" indent="0">
              <a:buNone/>
              <a:defRPr sz="1669"/>
            </a:lvl1pPr>
            <a:lvl2pPr marL="476951" indent="0">
              <a:buNone/>
              <a:defRPr sz="1460"/>
            </a:lvl2pPr>
            <a:lvl3pPr marL="953902" indent="0">
              <a:buNone/>
              <a:defRPr sz="1252"/>
            </a:lvl3pPr>
            <a:lvl4pPr marL="1430853" indent="0">
              <a:buNone/>
              <a:defRPr sz="1043"/>
            </a:lvl4pPr>
            <a:lvl5pPr marL="1907804" indent="0">
              <a:buNone/>
              <a:defRPr sz="1043"/>
            </a:lvl5pPr>
            <a:lvl6pPr marL="2384755" indent="0">
              <a:buNone/>
              <a:defRPr sz="1043"/>
            </a:lvl6pPr>
            <a:lvl7pPr marL="2861706" indent="0">
              <a:buNone/>
              <a:defRPr sz="1043"/>
            </a:lvl7pPr>
            <a:lvl8pPr marL="3338657" indent="0">
              <a:buNone/>
              <a:defRPr sz="1043"/>
            </a:lvl8pPr>
            <a:lvl9pPr marL="3815608" indent="0">
              <a:buNone/>
              <a:defRPr sz="1043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051063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55826" y="383299"/>
            <a:ext cx="8227636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826" y="1916484"/>
            <a:ext cx="8227636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826" y="6672698"/>
            <a:ext cx="214634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8B21C-D82D-413C-9B73-00BEAF578F8F}" type="datetimeFigureOut">
              <a:rPr lang="zh-TW" altLang="en-US" smtClean="0"/>
              <a:pPr/>
              <a:t>2019/10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59889" y="6672698"/>
            <a:ext cx="321951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37122" y="6672698"/>
            <a:ext cx="214634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C9A01-5967-48DD-B725-FA811151330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60734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53902" rtl="0" eaLnBrk="1" latinLnBrk="0" hangingPunct="1">
        <a:lnSpc>
          <a:spcPct val="90000"/>
        </a:lnSpc>
        <a:spcBef>
          <a:spcPct val="0"/>
        </a:spcBef>
        <a:buNone/>
        <a:defRPr sz="45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8476" indent="-238476" algn="l" defTabSz="953902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2921" kern="1200">
          <a:solidFill>
            <a:schemeClr val="tx1"/>
          </a:solidFill>
          <a:latin typeface="+mn-lt"/>
          <a:ea typeface="+mn-ea"/>
          <a:cs typeface="+mn-cs"/>
        </a:defRPr>
      </a:lvl1pPr>
      <a:lvl2pPr marL="715427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2504" kern="1200">
          <a:solidFill>
            <a:schemeClr val="tx1"/>
          </a:solidFill>
          <a:latin typeface="+mn-lt"/>
          <a:ea typeface="+mn-ea"/>
          <a:cs typeface="+mn-cs"/>
        </a:defRPr>
      </a:lvl2pPr>
      <a:lvl3pPr marL="1192378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2086" kern="1200">
          <a:solidFill>
            <a:schemeClr val="tx1"/>
          </a:solidFill>
          <a:latin typeface="+mn-lt"/>
          <a:ea typeface="+mn-ea"/>
          <a:cs typeface="+mn-cs"/>
        </a:defRPr>
      </a:lvl3pPr>
      <a:lvl4pPr marL="1669329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4pPr>
      <a:lvl5pPr marL="2146280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5pPr>
      <a:lvl6pPr marL="2623231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6pPr>
      <a:lvl7pPr marL="3100182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7pPr>
      <a:lvl8pPr marL="3577133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8pPr>
      <a:lvl9pPr marL="4054084" indent="-238476" algn="l" defTabSz="953902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1pPr>
      <a:lvl2pPr marL="476951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2pPr>
      <a:lvl3pPr marL="953902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3pPr>
      <a:lvl4pPr marL="1430853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4pPr>
      <a:lvl5pPr marL="1907804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5pPr>
      <a:lvl6pPr marL="2384755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6pPr>
      <a:lvl7pPr marL="2861706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7pPr>
      <a:lvl8pPr marL="3338657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8pPr>
      <a:lvl9pPr marL="3815608" algn="l" defTabSz="953902" rtl="0" eaLnBrk="1" latinLnBrk="0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402" r="19079"/>
          <a:stretch/>
        </p:blipFill>
        <p:spPr>
          <a:xfrm>
            <a:off x="4839373" y="551656"/>
            <a:ext cx="4466451" cy="4294664"/>
          </a:xfrm>
          <a:prstGeom prst="rect">
            <a:avLst/>
          </a:prstGeom>
        </p:spPr>
      </p:pic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7664" b="28079"/>
          <a:stretch/>
        </p:blipFill>
        <p:spPr>
          <a:xfrm>
            <a:off x="209836" y="551657"/>
            <a:ext cx="4467600" cy="4294663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xmlns="" id="{C10A89B1-7476-4138-A6FC-34F81BEF24E1}"/>
              </a:ext>
            </a:extLst>
          </p:cNvPr>
          <p:cNvSpPr/>
          <p:nvPr/>
        </p:nvSpPr>
        <p:spPr>
          <a:xfrm>
            <a:off x="533334" y="5000868"/>
            <a:ext cx="87724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/>
              <a:t>Figure </a:t>
            </a:r>
            <a:r>
              <a:rPr lang="en-US" altLang="zh-TW" b="1" dirty="0" err="1" smtClean="0"/>
              <a:t>S1</a:t>
            </a:r>
            <a:r>
              <a:rPr lang="zh-TW" altLang="en-US" b="1" dirty="0" smtClean="0"/>
              <a:t> </a:t>
            </a:r>
            <a:r>
              <a:rPr lang="en-US" altLang="zh-TW" dirty="0"/>
              <a:t>Small erythematous papules on trunk and extremities of the patient.</a:t>
            </a:r>
            <a:endParaRPr lang="zh-TW" altLang="zh-TW" dirty="0"/>
          </a:p>
        </p:txBody>
      </p:sp>
    </p:spTree>
    <p:extLst>
      <p:ext uri="{BB962C8B-B14F-4D97-AF65-F5344CB8AC3E}">
        <p14:creationId xmlns:p14="http://schemas.microsoft.com/office/powerpoint/2010/main" xmlns="" val="1070220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圖片 9" descr="一張含有 服飾 的圖片&#10;&#10;自動產生的描述">
            <a:extLst>
              <a:ext uri="{FF2B5EF4-FFF2-40B4-BE49-F238E27FC236}">
                <a16:creationId xmlns:a16="http://schemas.microsoft.com/office/drawing/2014/main" xmlns="" id="{2AB3ECA4-9966-4CA5-A0CB-6EFFCCAE6C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05684" y="215916"/>
            <a:ext cx="4494030" cy="3383740"/>
          </a:xfrm>
          <a:prstGeom prst="rect">
            <a:avLst/>
          </a:prstGeom>
        </p:spPr>
      </p:pic>
      <p:pic>
        <p:nvPicPr>
          <p:cNvPr id="3" name="圖片 2" descr="一張含有 地圖, 文字 的圖片&#10;&#10;自動產生的描述">
            <a:extLst>
              <a:ext uri="{FF2B5EF4-FFF2-40B4-BE49-F238E27FC236}">
                <a16:creationId xmlns:a16="http://schemas.microsoft.com/office/drawing/2014/main" xmlns="" id="{33FC4E43-6479-4B43-877F-68267DBBD1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654" y="215916"/>
            <a:ext cx="4494030" cy="338374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xmlns="" id="{AC042E41-EB51-43D7-8947-C64D5EEC46B1}"/>
              </a:ext>
            </a:extLst>
          </p:cNvPr>
          <p:cNvSpPr/>
          <p:nvPr/>
        </p:nvSpPr>
        <p:spPr>
          <a:xfrm>
            <a:off x="211654" y="217831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A</a:t>
            </a:r>
            <a:endParaRPr lang="zh-TW" altLang="en-US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xmlns="" id="{B8572C1B-29C2-4DC7-8C27-8006AD0E1564}"/>
              </a:ext>
            </a:extLst>
          </p:cNvPr>
          <p:cNvSpPr/>
          <p:nvPr/>
        </p:nvSpPr>
        <p:spPr>
          <a:xfrm>
            <a:off x="4759868" y="215916"/>
            <a:ext cx="309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B</a:t>
            </a:r>
            <a:endParaRPr lang="zh-TW" altLang="en-US" dirty="0"/>
          </a:p>
        </p:txBody>
      </p:sp>
      <p:sp>
        <p:nvSpPr>
          <p:cNvPr id="8" name="矩形 7"/>
          <p:cNvSpPr/>
          <p:nvPr/>
        </p:nvSpPr>
        <p:spPr>
          <a:xfrm>
            <a:off x="941108" y="3928813"/>
            <a:ext cx="764708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/>
              <a:t>Fig </a:t>
            </a:r>
            <a:r>
              <a:rPr lang="en-US" altLang="zh-TW" b="1" smtClean="0"/>
              <a:t>S2</a:t>
            </a:r>
            <a:r>
              <a:rPr lang="en-US" altLang="zh-TW" b="1" dirty="0" smtClean="0"/>
              <a:t> </a:t>
            </a:r>
            <a:r>
              <a:rPr lang="zh-TW" altLang="en-US" b="1" dirty="0" smtClean="0"/>
              <a:t> </a:t>
            </a:r>
            <a:r>
              <a:rPr lang="en-US" altLang="zh-TW" b="1" dirty="0"/>
              <a:t>Pathological finding for the skin rash</a:t>
            </a:r>
            <a:endParaRPr lang="zh-TW" altLang="zh-TW" b="1" dirty="0"/>
          </a:p>
          <a:p>
            <a:r>
              <a:rPr lang="en-US" altLang="zh-TW" dirty="0"/>
              <a:t>The biopsy specimen of an erythematous papules taken from right thigh showing (A) a superficial perivascular infiltrate  and (B) the infiltrate consisting of lymphocytes with eosinophils. (A. H&amp;E, </a:t>
            </a:r>
            <a:r>
              <a:rPr lang="en-US" altLang="zh-TW" dirty="0" err="1"/>
              <a:t>X20</a:t>
            </a:r>
            <a:r>
              <a:rPr lang="en-US" altLang="zh-TW" dirty="0"/>
              <a:t>; B. H&amp;E, </a:t>
            </a:r>
            <a:r>
              <a:rPr lang="en-US" altLang="zh-TW" dirty="0" err="1"/>
              <a:t>X200</a:t>
            </a:r>
            <a:r>
              <a:rPr lang="en-US" altLang="zh-TW" dirty="0"/>
              <a:t>, zoom in from the black box in figure </a:t>
            </a:r>
            <a:r>
              <a:rPr lang="en-US" altLang="zh-TW" dirty="0" err="1"/>
              <a:t>2A</a:t>
            </a:r>
            <a:r>
              <a:rPr lang="en-US" altLang="zh-TW" dirty="0"/>
              <a:t>. ).</a:t>
            </a:r>
            <a:endParaRPr lang="zh-TW" altLang="zh-TW" dirty="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xmlns="" id="{79392688-93B4-4DD1-9CC6-7B893B8C2046}"/>
              </a:ext>
            </a:extLst>
          </p:cNvPr>
          <p:cNvSpPr/>
          <p:nvPr/>
        </p:nvSpPr>
        <p:spPr>
          <a:xfrm>
            <a:off x="1862298" y="1402915"/>
            <a:ext cx="968584" cy="67640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599810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9</TotalTime>
  <Words>42</Words>
  <Application>Microsoft Office PowerPoint</Application>
  <PresentationFormat>Custom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佈景主題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陳亮宇</dc:creator>
  <cp:lastModifiedBy>0012761</cp:lastModifiedBy>
  <cp:revision>16</cp:revision>
  <dcterms:created xsi:type="dcterms:W3CDTF">2019-08-14T14:36:58Z</dcterms:created>
  <dcterms:modified xsi:type="dcterms:W3CDTF">2019-10-19T00:39:36Z</dcterms:modified>
</cp:coreProperties>
</file>